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7" r:id="rId3"/>
    <p:sldId id="260" r:id="rId4"/>
    <p:sldId id="263" r:id="rId5"/>
    <p:sldId id="262" r:id="rId6"/>
    <p:sldId id="266" r:id="rId7"/>
    <p:sldId id="26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42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6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98AC3-2281-9743-9B69-9CDB07AF39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E23970-F997-C041-B0F1-5E291FD715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660B15-5897-ED4C-BAE9-1AC940EB5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C35812-E522-7243-AA94-7FE89950F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B600C-753E-B949-B973-73E77E8CD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18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8481-1134-7440-9E73-C00FCC411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6C777F-1A3B-514E-B13B-A03083E540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E5A8BA-0DFC-A543-8C31-322AB3FB8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90316-E1FC-0F42-8906-C04D16759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2DADF-C87B-8F4E-B795-2CD1BB7BF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37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134669-4614-E04B-AC7B-C96E34A6F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1493B5-C333-C643-AD00-2E4A42111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CCF21-B446-C241-860D-C2F3775CF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F0752-D487-BD43-9AC9-48DEA65A1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DA7C3-C37B-9347-9FDB-D20669348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83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89048-C327-DD4F-B355-154655689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F73491-2AA6-2C41-B9DE-FB63633FED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418B5-5198-E943-8C52-6F1DB9395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F46B30-D246-9D44-B6C5-148F6E6A1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C08A5-5479-134D-B9C7-FC78BD748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30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E6736-F8B2-8843-8CE5-2C2EDB364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85B263-3ACB-3F49-92B7-2BCCF0ECE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5591A-099F-6B4B-ACB9-7F39331E5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49D4F-BF9D-7A40-A6F0-F91EF210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163016-7B9E-714E-8A81-A196F6183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42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0DC66-7BF4-0748-A739-849A5823C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68B0F6-B82D-5F49-A7CF-51348BA98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B21A8C-8129-A44F-9744-47303EEE34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F9ADE3-1261-1441-9F51-27E6B2D8A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516574-01A0-224F-A511-0CC472B04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C57622-656B-744B-95E0-3B8F28E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9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31B6F-A978-CE46-869A-A229BA26BD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CDC9AB-F3DC-B644-830B-AEAF30102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5F11FA-1EA7-1248-90BD-FF5B72056E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5F4F25-2011-4A4F-9376-59C2CFCFDE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734C7-F327-5349-AF57-095362069D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72B7D3-BCBC-6F41-AECD-CB8F223F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E584CE-EAC7-5C40-A727-B1B68DDD6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B10B4C-E1E6-0147-A01C-E5486B1DC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36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D5AA0-EAB1-8F48-BCF8-BBC2087B4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73C422-439B-6440-9629-AD895000C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40F4AA-5EB1-F14D-809D-738077E98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D46968-AB53-7E4C-9D30-2DCAD2DBA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632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E25157-0F74-EE42-82B1-E8EAD897D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198EF-0710-3748-AD63-27191145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C40C9A-E25E-4C4B-8286-BD71A76E2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48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77D30-EAD5-9941-9856-4E7C2AB4A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F23C83-FDAC-1E45-AA4C-60DCFD126E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D00E5-816C-804A-AF2E-2315AAAD2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050761-E065-FA46-B35E-D75AB8FF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24DD24-9E76-CB4C-BBEF-49BB0A14E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C9D214-6DAD-7A46-8421-DB708B507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69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482A0-CF67-A442-B92F-97A0FB14A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793791-EB10-CD48-907D-1A3E660BFF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BD21D6-ABAD-1A4F-85AC-15EB121460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1A0094-7BC7-7B45-92AA-8F7940A46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1F4D8C-3BDC-8945-815A-6F8BA25BB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3B94CF-EB9D-4642-9A8A-8BD7273A1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9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5E1092-0207-824B-B043-7504BAAE7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68D305-2D73-8541-85D3-40E25A86F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D7D83-B2E8-6246-B9F8-F1CD4C1109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D7BD2-CCE9-C04F-9295-3606F3EF204F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024BF-7208-194E-B14F-328EE0996C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3E3FA-D99E-1F40-B405-58A37E821C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C6C0F-9115-4A4E-BA9C-29B5A2D9A82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58F201-7F3A-D247-94B3-D56049D6934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6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i="1" dirty="0" err="1"/>
              <a:t>Sinus</a:t>
            </a:r>
            <a:r>
              <a:rPr lang="pt-BR" i="1" dirty="0"/>
              <a:t> </a:t>
            </a:r>
            <a:r>
              <a:rPr lang="pt-BR" i="1" dirty="0" err="1"/>
              <a:t>Tachycardia</a:t>
            </a:r>
            <a:r>
              <a:rPr lang="pt-BR" i="1" dirty="0"/>
              <a:t> </a:t>
            </a:r>
            <a:r>
              <a:rPr lang="pt-BR" i="1" dirty="0" err="1"/>
              <a:t>with</a:t>
            </a:r>
            <a:r>
              <a:rPr lang="pt-BR" i="1" dirty="0"/>
              <a:t> </a:t>
            </a:r>
            <a:r>
              <a:rPr lang="pt-BR" i="1" dirty="0" err="1"/>
              <a:t>Widened</a:t>
            </a:r>
            <a:r>
              <a:rPr lang="pt-BR" i="1" dirty="0"/>
              <a:t> QRS ECG </a:t>
            </a:r>
            <a:endParaRPr lang="en-US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C6E487-E49A-1D3B-E74E-B96B843283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01842BC-93B7-194F-EA42-A1B5C0622D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31" b="11458"/>
          <a:stretch/>
        </p:blipFill>
        <p:spPr bwMode="auto">
          <a:xfrm>
            <a:off x="1730217" y="1825625"/>
            <a:ext cx="8731566" cy="464470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  <a:ext uri="{53640926-AAD7-44d8-BBD7-CCE9431645EC}">
              <a14:shadowObscured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el="http://schemas.microsoft.com/office/2019/extlst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/>
            </a:ext>
          </a:extLst>
        </p:spPr>
      </p:pic>
    </p:spTree>
    <p:extLst>
      <p:ext uri="{BB962C8B-B14F-4D97-AF65-F5344CB8AC3E}">
        <p14:creationId xmlns:p14="http://schemas.microsoft.com/office/powerpoint/2010/main" val="182503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2AD16-F9CF-9942-B7B6-707774FAB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Radiograph (CXR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27E96B2-5E8B-695F-6464-14433E7C86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5957" y="1452789"/>
            <a:ext cx="5040086" cy="504008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565105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B50FD-C2F8-CF48-97A0-433B33CCE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A08D03-20AE-9A4E-86F5-2D6065674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ite blood count (WBC)		15.0 x 1000/mm</a:t>
            </a:r>
            <a:r>
              <a:rPr lang="en-US" baseline="30000" dirty="0"/>
              <a:t>3</a:t>
            </a:r>
            <a:endParaRPr lang="en-US" dirty="0"/>
          </a:p>
          <a:p>
            <a:r>
              <a:rPr lang="en-US" dirty="0"/>
              <a:t>Hemoglobin (Hgb)			14.0 g/dL</a:t>
            </a:r>
          </a:p>
          <a:p>
            <a:r>
              <a:rPr lang="en-US" dirty="0"/>
              <a:t>Hematocrit (HCT)				40.0%</a:t>
            </a:r>
          </a:p>
          <a:p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				250 x 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42916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21C0E-D50D-874F-BED1-8BF190BBBB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rehensive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CB1529-5642-8446-87D6-0BAE8F34A3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34886"/>
            <a:ext cx="10515600" cy="4957989"/>
          </a:xfrm>
        </p:spPr>
        <p:txBody>
          <a:bodyPr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Sodium 				140 mEq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Chloride  				100 mEq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Potassium				4.7 mEq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Bicarbonate (HCO</a:t>
            </a:r>
            <a:r>
              <a:rPr lang="en-US" sz="2400" baseline="-25000" dirty="0">
                <a:effectLst/>
                <a:ea typeface="Arial Unicode MS" panose="020B0604020202020204" pitchFamily="34" charset="-128"/>
              </a:rPr>
              <a:t>3</a:t>
            </a:r>
            <a:r>
              <a:rPr lang="en-US" sz="2400" dirty="0">
                <a:effectLst/>
                <a:ea typeface="Arial Unicode MS" panose="020B0604020202020204" pitchFamily="34" charset="-128"/>
              </a:rPr>
              <a:t>)			19 mEq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Anion Gab				21 mEq/L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Blood Urea Nitrogen (BUN)		30 mg/dL 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Creatine (Cr)		 		1.1 mg/dL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Glucose 				100 m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Calcium					9.5 m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Total Protein				7.0 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Albumin				40 units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Alkaline </a:t>
            </a:r>
            <a:r>
              <a:rPr lang="en-US" sz="2400" dirty="0" err="1">
                <a:effectLst/>
                <a:ea typeface="Arial Unicode MS" panose="020B0604020202020204" pitchFamily="34" charset="-128"/>
              </a:rPr>
              <a:t>Phoshatase</a:t>
            </a:r>
            <a:r>
              <a:rPr lang="en-US" sz="2400" dirty="0">
                <a:effectLst/>
                <a:ea typeface="Arial Unicode MS" panose="020B0604020202020204" pitchFamily="34" charset="-128"/>
              </a:rPr>
              <a:t>			100 units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Aspartate aminotransferase (AST)	90 units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Arial Unicode MS" panose="020B0604020202020204" pitchFamily="34" charset="-128"/>
              </a:rPr>
              <a:t>Alanine aminotransferase (ALT)	60 units/L</a:t>
            </a:r>
          </a:p>
        </p:txBody>
      </p:sp>
    </p:spTree>
    <p:extLst>
      <p:ext uri="{BB962C8B-B14F-4D97-AF65-F5344CB8AC3E}">
        <p14:creationId xmlns:p14="http://schemas.microsoft.com/office/powerpoint/2010/main" val="25151439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Toxicology Scre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lor 				yellow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ppearance 				clear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pecific gravity 			1.010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 					7.0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Glucose 				negative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Ketones 				negative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oglobin				negative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eukocyte esterase 			negative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Nitrites 				negative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White blood cells (WBC) 		0 WBCs/high powered field (HPF)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Red blood cells (RBC) 		0 RBCs/HPF 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quamous epithelial cells 		1 cells/HPF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acteria				negative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273514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Toxicology Scre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pt-BR" sz="2400" dirty="0" err="1">
                <a:effectLst/>
                <a:ea typeface="Times New Roman" panose="02020603050405020304" pitchFamily="18" charset="0"/>
              </a:rPr>
              <a:t>Tetrahydrocannabinol</a:t>
            </a:r>
            <a:r>
              <a:rPr lang="pt-BR" sz="2400" dirty="0">
                <a:effectLst/>
                <a:ea typeface="Times New Roman" panose="02020603050405020304" pitchFamily="18" charset="0"/>
              </a:rPr>
              <a:t> (THC)	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Times New Roman" panose="02020603050405020304" pitchFamily="18" charset="0"/>
              </a:rPr>
              <a:t>Phencyclidine (PCP)			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2400" dirty="0">
                <a:effectLst/>
                <a:ea typeface="Times New Roman" panose="02020603050405020304" pitchFamily="18" charset="0"/>
              </a:rPr>
              <a:t>Benzodiazepines			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2400" dirty="0" err="1">
                <a:effectLst/>
                <a:ea typeface="Times New Roman" panose="02020603050405020304" pitchFamily="18" charset="0"/>
              </a:rPr>
              <a:t>Barbiturates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				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Times New Roman" panose="02020603050405020304" pitchFamily="18" charset="0"/>
              </a:rPr>
              <a:t>Methadone				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Times New Roman" panose="02020603050405020304" pitchFamily="18" charset="0"/>
              </a:rPr>
              <a:t>Cocaine				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nl-NL" sz="2400" dirty="0" err="1">
                <a:effectLst/>
                <a:ea typeface="Times New Roman" panose="02020603050405020304" pitchFamily="18" charset="0"/>
              </a:rPr>
              <a:t>Amphetamines</a:t>
            </a:r>
            <a:r>
              <a:rPr lang="nl-NL" sz="2400" dirty="0">
                <a:effectLst/>
                <a:ea typeface="Times New Roman" panose="02020603050405020304" pitchFamily="18" charset="0"/>
              </a:rPr>
              <a:t>			None </a:t>
            </a:r>
            <a:r>
              <a:rPr lang="nl-NL" sz="2400" dirty="0" err="1">
                <a:effectLst/>
                <a:ea typeface="Times New Roman" panose="02020603050405020304" pitchFamily="18" charset="0"/>
              </a:rPr>
              <a:t>Detected</a:t>
            </a:r>
            <a:endParaRPr lang="en-US" sz="2400" dirty="0"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Times New Roman" panose="02020603050405020304" pitchFamily="18" charset="0"/>
              </a:rPr>
              <a:t>MDMA				None Detected</a:t>
            </a:r>
            <a:endParaRPr lang="en-US" sz="2400" dirty="0">
              <a:effectLst/>
              <a:ea typeface="Arial Unicode MS" panose="020B0604020202020204" pitchFamily="34" charset="-128"/>
            </a:endParaRP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022669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67</Words>
  <Application>Microsoft Macintosh PowerPoint</Application>
  <PresentationFormat>Widescreen</PresentationFormat>
  <Paragraphs>4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Stimulus Inventory</vt:lpstr>
      <vt:lpstr>Sinus Tachycardia with Widened QRS ECG </vt:lpstr>
      <vt:lpstr>Chest Radiograph (CXR)</vt:lpstr>
      <vt:lpstr>Complete Blood Count</vt:lpstr>
      <vt:lpstr>Comprehensive Metabolic Panel</vt:lpstr>
      <vt:lpstr>Urine Toxicology Screen</vt:lpstr>
      <vt:lpstr>Urine Toxicology Scree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Wray, Alisa</cp:lastModifiedBy>
  <cp:revision>19</cp:revision>
  <dcterms:created xsi:type="dcterms:W3CDTF">2021-10-07T03:47:09Z</dcterms:created>
  <dcterms:modified xsi:type="dcterms:W3CDTF">2023-01-17T02:22:22Z</dcterms:modified>
</cp:coreProperties>
</file>